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F22E47-0380-4980-A47E-3063166269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A6F99-DE6D-44B0-AA8B-13858C9A308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E2DE5F-AE30-4112-AD48-89A69FBCB0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4A1AB-A4B7-4EBC-B76D-80FE5E5BC46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2974BB-5BF7-4266-8ADF-5D985FFA1D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522D11-6F95-4554-91D7-4A40805A42B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4AD580-D1D6-4509-80C7-43E2C58348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0A19B-44AD-4F02-B4FC-BF9A6A4B8E2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13C701-C8D1-4381-8699-FAAEE265C9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2ED7A9-B89F-4A22-8A82-873C968E72A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2EE9233-AA72-4082-890A-40D7BCF75BF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17FFCF-E282-4908-8896-0602F0649BC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E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F10353-3A1D-4465-A45A-782C91C262B9}" type="slidenum">
              <a:rPr b="0" lang="es-E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2" descr=""/>
          <p:cNvPicPr/>
          <p:nvPr/>
        </p:nvPicPr>
        <p:blipFill>
          <a:blip r:embed="rId1"/>
          <a:stretch/>
        </p:blipFill>
        <p:spPr>
          <a:xfrm>
            <a:off x="677880" y="1000080"/>
            <a:ext cx="5460840" cy="369576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3" descr=""/>
          <p:cNvPicPr/>
          <p:nvPr/>
        </p:nvPicPr>
        <p:blipFill>
          <a:blip r:embed="rId2"/>
          <a:stretch/>
        </p:blipFill>
        <p:spPr>
          <a:xfrm>
            <a:off x="677880" y="5113440"/>
            <a:ext cx="5460840" cy="3244680"/>
          </a:xfrm>
          <a:prstGeom prst="rect">
            <a:avLst/>
          </a:prstGeom>
          <a:ln w="0">
            <a:noFill/>
          </a:ln>
        </p:spPr>
      </p:pic>
      <p:sp>
        <p:nvSpPr>
          <p:cNvPr id="43" name="5 CuadroTexto"/>
          <p:cNvSpPr/>
          <p:nvPr/>
        </p:nvSpPr>
        <p:spPr>
          <a:xfrm>
            <a:off x="142920" y="8715240"/>
            <a:ext cx="1685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Calibri"/>
              </a:rPr>
              <a:t>Supplemental Figure 4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6 Rectángulo"/>
          <p:cNvSpPr/>
          <p:nvPr/>
        </p:nvSpPr>
        <p:spPr>
          <a:xfrm>
            <a:off x="1428840" y="1071720"/>
            <a:ext cx="357120" cy="14256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7 Rectángulo"/>
          <p:cNvSpPr/>
          <p:nvPr/>
        </p:nvSpPr>
        <p:spPr>
          <a:xfrm>
            <a:off x="3714840" y="1071720"/>
            <a:ext cx="357120" cy="142560"/>
          </a:xfrm>
          <a:prstGeom prst="rect">
            <a:avLst/>
          </a:prstGeom>
          <a:solidFill>
            <a:srgbClr val="bfbfb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8 CuadroTexto"/>
          <p:cNvSpPr/>
          <p:nvPr/>
        </p:nvSpPr>
        <p:spPr>
          <a:xfrm>
            <a:off x="1785960" y="958680"/>
            <a:ext cx="1785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Before anti-TNF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/DMARDs therap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9 CuadroTexto"/>
          <p:cNvSpPr/>
          <p:nvPr/>
        </p:nvSpPr>
        <p:spPr>
          <a:xfrm>
            <a:off x="4071960" y="958680"/>
            <a:ext cx="17859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After anti-TNF</a:t>
            </a:r>
            <a:r>
              <a:rPr b="0" lang="el-GR" sz="1000" spc="-1" strike="noStrike">
                <a:solidFill>
                  <a:srgbClr val="000000"/>
                </a:solidFill>
                <a:latin typeface="Calibri"/>
              </a:rPr>
              <a:t>α</a:t>
            </a:r>
            <a:r>
              <a:rPr b="0" lang="es-ES" sz="1000" spc="-1" strike="noStrike">
                <a:solidFill>
                  <a:srgbClr val="000000"/>
                </a:solidFill>
                <a:latin typeface="Calibri"/>
              </a:rPr>
              <a:t>/DMARDs therapy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10 CuadroTexto"/>
          <p:cNvSpPr/>
          <p:nvPr/>
        </p:nvSpPr>
        <p:spPr>
          <a:xfrm>
            <a:off x="2730600" y="500040"/>
            <a:ext cx="135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</a:rPr>
              <a:t>Responder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11 CuadroTexto"/>
          <p:cNvSpPr/>
          <p:nvPr/>
        </p:nvSpPr>
        <p:spPr>
          <a:xfrm>
            <a:off x="2516040" y="5184720"/>
            <a:ext cx="17859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400" spc="-1" strike="noStrike">
                <a:solidFill>
                  <a:srgbClr val="000000"/>
                </a:solidFill>
                <a:latin typeface="Calibri"/>
              </a:rPr>
              <a:t>Non- Responders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12 CuadroTexto"/>
          <p:cNvSpPr/>
          <p:nvPr/>
        </p:nvSpPr>
        <p:spPr>
          <a:xfrm>
            <a:off x="571680" y="54936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13 CuadroTexto"/>
          <p:cNvSpPr/>
          <p:nvPr/>
        </p:nvSpPr>
        <p:spPr>
          <a:xfrm>
            <a:off x="571680" y="4970520"/>
            <a:ext cx="3571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800" spc="-1" strike="noStrike">
                <a:solidFill>
                  <a:srgbClr val="000000"/>
                </a:solidFill>
                <a:latin typeface="Calibri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1-13T12:06:37Z</dcterms:created>
  <dc:creator>Chary</dc:creator>
  <dc:description/>
  <dc:language>en-US</dc:language>
  <cp:lastModifiedBy>Chary</cp:lastModifiedBy>
  <dcterms:modified xsi:type="dcterms:W3CDTF">2015-01-13T14:03:25Z</dcterms:modified>
  <cp:revision>1</cp:revision>
  <dc:subject/>
  <dc:title>Diapositiva 1</dc:title>
</cp:coreProperties>
</file>